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61A119A-6318-4C1C-97D1-71B175932EFB}" v="6" dt="2020-03-01T23:43:06.8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5" d="100"/>
          <a:sy n="45" d="100"/>
        </p:scale>
        <p:origin x="54" y="9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6AFEE2-D293-47D8-8337-52F54704A1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358CDBD-C9BB-406F-A96D-CF9128C804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07A6FF-D3F6-4B35-A465-93E81AEEC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B7BB68-57A0-4F0D-86E8-BA18E8A92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58589B-D15E-4DB9-A6D6-711FF7769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508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8688A7-EF67-4DA4-B818-59EBCD676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8AC826-92E9-4D5B-9BAC-3999B1F638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DEDA43-8F7A-46F4-AF03-D1F6880E5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41383C-BD59-464C-A2F4-B2AF15301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DF153F-349D-45A7-9F43-B6B35D374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571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1C0628-7747-475F-AEE0-CBF7856E72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58F18B-0DF1-4272-8471-C33E71DA4B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584D00-141A-48F7-8BBD-67E0F028F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F652BB-5825-40C6-88E1-850324992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BCEBCA-425C-40FD-AD1A-20D8F8F94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834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771C3A-1CF0-4485-8B24-48CE0AF512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E3B4A5-3B69-44C7-BFB0-51F27401BE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B26434-9EDD-4571-96E9-2FAB920FC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B06121-A457-448F-A585-7AD8104BC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0C6016-4258-45A3-BD7A-C67F90129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174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2893A6-1520-4565-B573-3003436AEB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4342DF-AA5A-4DBD-934C-9772EE2779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7B6B36-188E-4BB2-8812-4E006F442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0EC5A3-5689-452E-AD9B-E325454FD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D23F86-C6D6-48F3-A79A-C6C425A60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725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036432-62A8-4E57-BBBB-100107C15E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127E9F-F8AF-49EE-B889-CDEF9C0E30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C09D99-8DF8-4D40-8E70-95D372B42A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D54E26-C7DC-4EEC-A7D0-BDB1E4594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BDDE7D-AFD6-4726-99A6-28112CAE6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29ED4D-F6F2-4A9F-8CB8-E2775EA6C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077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EEC25-A5C6-4109-8756-EAC740E8B7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BAE7A7-FE6E-4FB7-A99A-8B29B3D1EB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029245-A954-4092-A80B-2376F14286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5C28F69-29E7-4C79-B9C8-628019C08B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AEC8FC-EDCB-47A4-A918-2981F7F9D8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3BB49D-5615-414D-8F6A-198F2D28C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DD765E-3696-44FD-B7AC-0C1828641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145B4D-B72B-4CE6-8094-01DAEE2AC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128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DD3C42-585B-4DB2-90F2-97DEFD9796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AECDE3-D894-4C38-8E3F-98A3097A8E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45C62B-0C08-47A5-B93B-1D32F6685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8B8E84-9903-40F9-839F-FFCD00695A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724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749B58-9F6D-47BB-821E-52CC7B5D2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1C89E2-3F1B-4824-8361-ECBD16F6E3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687252-839D-4CA2-AD53-4028168BE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18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7CAD1D-FA2D-44AE-A75E-C4913ED27F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FBEE9B-572C-423C-BA19-83DBEDDA45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0FCB26-CB99-49EC-9B11-677EA8AC3E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94150A-C538-49E6-A665-B21BF2BEE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8712EB-5897-4968-B6B4-9251339F9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006957-D713-4F84-BF55-1C4E665A7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894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EDCEB0-A870-43D1-9B18-BC50C2FA19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C84C01B-D410-4FD5-A6B6-6C60473A9A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7B4CC7-3C34-4A4E-A907-F1FA81DFDD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ED634D-289F-4A19-8861-A9BF9453C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18DF44-0797-4D78-9CA5-5BEAF11CAA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02CDB3-E805-42EA-9CF0-C52ACF29E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875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229188B-1DC1-4578-9284-6B10C0D1E7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BC45CF-0321-4FBB-A457-91D22D7478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664ED4-C210-448D-AA4B-0E626D8078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BF2846-249B-471C-856A-183401B702DA}" type="datetimeFigureOut">
              <a:rPr lang="en-US" smtClean="0"/>
              <a:t>3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E2FBDE-0001-4677-AF95-5A0BEBF55E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F33ADF-D8D8-4D26-B7F5-1FD16D4AD0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1D4412-5CEF-4333-A41A-304F57127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023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E6E1F0D-6912-4F28-A856-031901B584C3}"/>
              </a:ext>
            </a:extLst>
          </p:cNvPr>
          <p:cNvSpPr txBox="1"/>
          <p:nvPr/>
        </p:nvSpPr>
        <p:spPr>
          <a:xfrm>
            <a:off x="4352925" y="152400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S8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9AC4AAC-E79C-4192-B572-34A647385505}"/>
              </a:ext>
            </a:extLst>
          </p:cNvPr>
          <p:cNvSpPr txBox="1"/>
          <p:nvPr/>
        </p:nvSpPr>
        <p:spPr>
          <a:xfrm>
            <a:off x="781050" y="104775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F19BE8E-0997-413B-BAFC-504FD60C2D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5531" y="800100"/>
            <a:ext cx="10151593" cy="567882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AF0513A-4F49-4A78-AF61-85500029CC4F}"/>
              </a:ext>
            </a:extLst>
          </p:cNvPr>
          <p:cNvSpPr txBox="1"/>
          <p:nvPr/>
        </p:nvSpPr>
        <p:spPr>
          <a:xfrm>
            <a:off x="8382000" y="861625"/>
            <a:ext cx="2096536" cy="369332"/>
          </a:xfrm>
          <a:prstGeom prst="rect">
            <a:avLst/>
          </a:prstGeom>
        </p:spPr>
        <p:style>
          <a:lnRef idx="1">
            <a:schemeClr val="accent4"/>
          </a:lnRef>
          <a:fillRef idx="3">
            <a:schemeClr val="accent4"/>
          </a:fillRef>
          <a:effectRef idx="2">
            <a:schemeClr val="accent4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tx1"/>
                </a:solidFill>
              </a:rPr>
              <a:t>CDDP-sensitive cells</a:t>
            </a:r>
          </a:p>
        </p:txBody>
      </p:sp>
    </p:spTree>
    <p:extLst>
      <p:ext uri="{BB962C8B-B14F-4D97-AF65-F5344CB8AC3E}">
        <p14:creationId xmlns:p14="http://schemas.microsoft.com/office/powerpoint/2010/main" val="31205586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7842D29-5A9E-4700-AC23-C6A65E90F9B9}"/>
              </a:ext>
            </a:extLst>
          </p:cNvPr>
          <p:cNvSpPr txBox="1"/>
          <p:nvPr/>
        </p:nvSpPr>
        <p:spPr>
          <a:xfrm>
            <a:off x="4352925" y="152400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S8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BE9DF71-6262-4EF0-AB13-C07737DD3353}"/>
              </a:ext>
            </a:extLst>
          </p:cNvPr>
          <p:cNvSpPr txBox="1"/>
          <p:nvPr/>
        </p:nvSpPr>
        <p:spPr>
          <a:xfrm>
            <a:off x="737769" y="723900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3A7160D-1F24-4738-93E8-F05566EBC6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5559" y="871506"/>
            <a:ext cx="9791515" cy="511498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3B7F50E-2AA2-4007-8521-A41917192FBF}"/>
              </a:ext>
            </a:extLst>
          </p:cNvPr>
          <p:cNvSpPr txBox="1"/>
          <p:nvPr/>
        </p:nvSpPr>
        <p:spPr>
          <a:xfrm>
            <a:off x="8382000" y="861625"/>
            <a:ext cx="2096536" cy="369332"/>
          </a:xfrm>
          <a:prstGeom prst="rect">
            <a:avLst/>
          </a:prstGeom>
        </p:spPr>
        <p:style>
          <a:lnRef idx="3">
            <a:schemeClr val="lt1"/>
          </a:lnRef>
          <a:fillRef idx="1">
            <a:schemeClr val="accent4"/>
          </a:fillRef>
          <a:effectRef idx="1">
            <a:schemeClr val="accent4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tx1"/>
                </a:solidFill>
              </a:rPr>
              <a:t>CDDP-sensitive cells</a:t>
            </a:r>
          </a:p>
        </p:txBody>
      </p:sp>
    </p:spTree>
    <p:extLst>
      <p:ext uri="{BB962C8B-B14F-4D97-AF65-F5344CB8AC3E}">
        <p14:creationId xmlns:p14="http://schemas.microsoft.com/office/powerpoint/2010/main" val="37414054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88AFD0A-D2C1-4E0A-8FAE-4DE1005D01EA}"/>
              </a:ext>
            </a:extLst>
          </p:cNvPr>
          <p:cNvSpPr txBox="1"/>
          <p:nvPr/>
        </p:nvSpPr>
        <p:spPr>
          <a:xfrm>
            <a:off x="4352925" y="152400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S8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61D8957-478D-4ED1-AC9E-E35546B23D61}"/>
              </a:ext>
            </a:extLst>
          </p:cNvPr>
          <p:cNvSpPr txBox="1"/>
          <p:nvPr/>
        </p:nvSpPr>
        <p:spPr>
          <a:xfrm>
            <a:off x="781050" y="1047750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E04C42B-321D-4B27-A0A9-14606D450C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2851" y="647700"/>
            <a:ext cx="9802349" cy="578328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A0023C0-1CA8-414F-994D-2A6E54AB89F8}"/>
              </a:ext>
            </a:extLst>
          </p:cNvPr>
          <p:cNvSpPr txBox="1"/>
          <p:nvPr/>
        </p:nvSpPr>
        <p:spPr>
          <a:xfrm>
            <a:off x="8382000" y="861625"/>
            <a:ext cx="2084353" cy="369332"/>
          </a:xfrm>
          <a:prstGeom prst="rect">
            <a:avLst/>
          </a:prstGeom>
        </p:spPr>
        <p:style>
          <a:lnRef idx="3">
            <a:schemeClr val="lt1"/>
          </a:lnRef>
          <a:fillRef idx="1">
            <a:schemeClr val="accent4"/>
          </a:fillRef>
          <a:effectRef idx="1">
            <a:schemeClr val="accent4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tx1"/>
                </a:solidFill>
              </a:rPr>
              <a:t>CDDP-resistant cells</a:t>
            </a:r>
          </a:p>
        </p:txBody>
      </p:sp>
    </p:spTree>
    <p:extLst>
      <p:ext uri="{BB962C8B-B14F-4D97-AF65-F5344CB8AC3E}">
        <p14:creationId xmlns:p14="http://schemas.microsoft.com/office/powerpoint/2010/main" val="36182440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18</Words>
  <Application>Microsoft Office PowerPoint</Application>
  <PresentationFormat>Widescreen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nkata Ramesh Dasari</dc:creator>
  <cp:lastModifiedBy>Radhika Gogoi</cp:lastModifiedBy>
  <cp:revision>3</cp:revision>
  <dcterms:created xsi:type="dcterms:W3CDTF">2020-03-01T22:13:33Z</dcterms:created>
  <dcterms:modified xsi:type="dcterms:W3CDTF">2020-03-02T12:00:52Z</dcterms:modified>
</cp:coreProperties>
</file>